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科研\黄瓜皮色测序\自己投稿\整理图表\Supplemental materials\Figure S2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1371600"/>
            <a:ext cx="8783637" cy="38893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15118" y="5761892"/>
            <a:ext cx="8610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ure S2.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The correlation analysis and principal component analysis (PCA) in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Lv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Bai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fruit.</a:t>
            </a:r>
            <a:endParaRPr lang="zh-CN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55091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PC</cp:lastModifiedBy>
  <cp:revision>1</cp:revision>
  <dcterms:created xsi:type="dcterms:W3CDTF">2006-08-16T00:00:00Z</dcterms:created>
  <dcterms:modified xsi:type="dcterms:W3CDTF">2020-04-16T07:35:30Z</dcterms:modified>
</cp:coreProperties>
</file>